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12AF7-3EF0-459C-BFCE-F7F3145EB5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2B16A-4798-45C1-BA34-78F448D0E4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79995-ADE4-4C87-80D8-327CECF064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483F4-964B-4DFB-9641-32016AEE5F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2A8CD-873C-44B7-A6EC-78485F3E5E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3B06F-6304-4826-8369-184E2108A5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E1EB2-0F07-43D4-BCEE-1DD8B91B15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2DEFE-E3A4-47B4-B0A1-471882733C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52C72-C4E3-4A8B-A22C-257A555327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9A77B-1EED-46BD-95CE-288116497B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9DEDB-6921-40F9-B034-9568E6C02A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4359E-EB57-4DC5-929A-A210E409D6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77042C-1BF3-4DED-BEB0-4BA8D1F972B9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51240" y="1962000"/>
            <a:ext cx="38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782880" y="1962000"/>
            <a:ext cx="38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156120" y="2249640"/>
            <a:ext cx="2086920" cy="3312720"/>
            <a:chOff x="3156120" y="2249640"/>
            <a:chExt cx="2086920" cy="3312720"/>
          </a:xfrm>
        </p:grpSpPr>
        <p:pic>
          <p:nvPicPr>
            <p:cNvPr id="44" name="" descr=""/>
            <p:cNvPicPr/>
            <p:nvPr/>
          </p:nvPicPr>
          <p:blipFill>
            <a:blip r:embed="rId1"/>
            <a:srcRect l="49513" t="14847" r="30708" b="12554"/>
            <a:stretch/>
          </p:blipFill>
          <p:spPr>
            <a:xfrm>
              <a:off x="3156120" y="2249640"/>
              <a:ext cx="1012680" cy="331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2"/>
            <a:srcRect l="49513" t="13304" r="29066" b="12554"/>
            <a:stretch/>
          </p:blipFill>
          <p:spPr>
            <a:xfrm>
              <a:off x="4168800" y="2249640"/>
              <a:ext cx="1074240" cy="3312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6" name=""/>
          <p:cNvSpPr/>
          <p:nvPr/>
        </p:nvSpPr>
        <p:spPr>
          <a:xfrm>
            <a:off x="76320" y="517680"/>
            <a:ext cx="9067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.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pecificity of Affinity purification of FP-TAMRA labeled urine.  Beads conjugated with an anti-HIV antibody did not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nrich FP-TAMRA labeled bands. 1)  FP-TAMRA labeled starting material. 2) Material eluted from anti-HIV column. 3)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arting material total protein. 4) Protein eluted from anti-HIV colum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410000" y="1962000"/>
            <a:ext cx="38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862520" y="1962000"/>
            <a:ext cx="38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L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766600" y="1492200"/>
            <a:ext cx="1884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erine hydrol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B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894840" y="1492200"/>
            <a:ext cx="1704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  <a:ea typeface="Arial"/>
              </a:rPr>
              <a:t>Total protein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  <a:ea typeface="Arial"/>
              </a:rPr>
              <a:t>Sypro Rub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7T17:43:52Z</dcterms:created>
  <dc:creator>Winnipeg Regional Health Authority</dc:creator>
  <dc:description/>
  <dc:language>en-US</dc:language>
  <cp:lastModifiedBy>Winnipeg Regional Health Authority</cp:lastModifiedBy>
  <dcterms:modified xsi:type="dcterms:W3CDTF">2013-09-23T22:04:52Z</dcterms:modified>
  <cp:revision>549</cp:revision>
  <dc:subject/>
  <dc:title>NOVEL BIOMARKERS OF IFTA,  RENAL ALLOGRAFT DYSFUNCTION AND LOSS</dc:title>
</cp:coreProperties>
</file>